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7" r:id="rId2"/>
  </p:sldIdLst>
  <p:sldSz cx="6858000" cy="9144000" type="screen4x3"/>
  <p:notesSz cx="6794500" cy="9982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tandardabschnitt" id="{8B9D7920-36D0-404C-A201-213143DFBD09}">
          <p14:sldIdLst>
            <p14:sldId id="277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hael Fleischer" initials="MFl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99" autoAdjust="0"/>
    <p:restoredTop sz="94608" autoAdjust="0"/>
  </p:normalViewPr>
  <p:slideViewPr>
    <p:cSldViewPr>
      <p:cViewPr>
        <p:scale>
          <a:sx n="125" d="100"/>
          <a:sy n="125" d="100"/>
        </p:scale>
        <p:origin x="-2352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48100" y="0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207B54-3EAD-41A2-9352-A64606E391C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48100" y="9482138"/>
            <a:ext cx="2944813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7D634A-284F-4D9E-B1D0-2C5BCE8A3D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5641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9A88D9-F2BA-41FC-9080-83DF67410D25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93900" y="749300"/>
            <a:ext cx="2806700" cy="3743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41545"/>
            <a:ext cx="5435600" cy="449199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81358"/>
            <a:ext cx="2944283" cy="49911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2BE942-E908-4AA3-ACE1-A14A842573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5023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993900" y="749300"/>
            <a:ext cx="2806700" cy="37433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2BE942-E908-4AA3-ACE1-A14A8425737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5426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357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7384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832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163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829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493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197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868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562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982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58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35D1A-A57B-4748-B2D7-4EF906F89C07}" type="datetimeFigureOut">
              <a:rPr lang="en-US" smtClean="0"/>
              <a:t>5/22/2020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6DBBB7-F045-4727-87FC-2B18966AB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835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284768" y="2019758"/>
            <a:ext cx="6573232" cy="3886481"/>
            <a:chOff x="379690" y="26011"/>
            <a:chExt cx="8764309" cy="5181973"/>
          </a:xfrm>
        </p:grpSpPr>
        <p:grpSp>
          <p:nvGrpSpPr>
            <p:cNvPr id="9" name="Gruppieren 8"/>
            <p:cNvGrpSpPr/>
            <p:nvPr/>
          </p:nvGrpSpPr>
          <p:grpSpPr>
            <a:xfrm>
              <a:off x="379690" y="141226"/>
              <a:ext cx="7980310" cy="5066758"/>
              <a:chOff x="379690" y="141226"/>
              <a:chExt cx="7980310" cy="5066758"/>
            </a:xfrm>
          </p:grpSpPr>
          <p:sp>
            <p:nvSpPr>
              <p:cNvPr id="4" name="Textfeld 3"/>
              <p:cNvSpPr txBox="1"/>
              <p:nvPr/>
            </p:nvSpPr>
            <p:spPr>
              <a:xfrm>
                <a:off x="379690" y="141226"/>
                <a:ext cx="2597772" cy="34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1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pplementary</a:t>
                </a:r>
                <a:r>
                  <a:rPr lang="de-DE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11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gure</a:t>
                </a:r>
                <a:r>
                  <a:rPr lang="de-DE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11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endParaRPr lang="de-DE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8" name="Gruppieren 7"/>
              <p:cNvGrpSpPr/>
              <p:nvPr/>
            </p:nvGrpSpPr>
            <p:grpSpPr>
              <a:xfrm>
                <a:off x="509460" y="1177409"/>
                <a:ext cx="7850540" cy="4030575"/>
                <a:chOff x="509460" y="1177409"/>
                <a:chExt cx="7850540" cy="4030575"/>
              </a:xfrm>
            </p:grpSpPr>
            <p:pic>
              <p:nvPicPr>
                <p:cNvPr id="3077" name="Picture 5"/>
                <p:cNvPicPr preferRelativeResize="0">
                  <a:picLocks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501160" y="2675862"/>
                  <a:ext cx="2710800" cy="22212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076" name="Picture 4"/>
                <p:cNvPicPr preferRelativeResize="0">
                  <a:picLocks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125318" y="2675862"/>
                  <a:ext cx="2710800" cy="22212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1" name="Textfeld 10"/>
                <p:cNvSpPr txBox="1"/>
                <p:nvPr/>
              </p:nvSpPr>
              <p:spPr>
                <a:xfrm>
                  <a:off x="683288" y="1686692"/>
                  <a:ext cx="83456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750" b="1" dirty="0">
                      <a:latin typeface="Symbol" panose="05050102010706020507" pitchFamily="18" charset="2"/>
                      <a:cs typeface="Times New Roman" panose="02020603050405020304" pitchFamily="18" charset="0"/>
                    </a:rPr>
                    <a:t>b</a:t>
                  </a:r>
                  <a:r>
                    <a:rPr lang="de-DE" sz="7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  <a:r>
                    <a:rPr lang="de-DE" sz="75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tin</a:t>
                  </a:r>
                  <a:endParaRPr lang="en-US" sz="7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2" name="Textfeld 11"/>
                <p:cNvSpPr txBox="1"/>
                <p:nvPr/>
              </p:nvSpPr>
              <p:spPr>
                <a:xfrm>
                  <a:off x="509460" y="1412776"/>
                  <a:ext cx="11822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75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ynaptotagmin</a:t>
                  </a:r>
                  <a:r>
                    <a:rPr lang="de-DE" sz="7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1</a:t>
                  </a:r>
                  <a:endParaRPr lang="en-US" sz="7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3" name="Textfeld 32"/>
                <p:cNvSpPr txBox="1"/>
                <p:nvPr/>
              </p:nvSpPr>
              <p:spPr>
                <a:xfrm>
                  <a:off x="4667811" y="1704520"/>
                  <a:ext cx="83456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750" b="1" dirty="0">
                      <a:latin typeface="Symbol" panose="05050102010706020507" pitchFamily="18" charset="2"/>
                      <a:cs typeface="Times New Roman" panose="02020603050405020304" pitchFamily="18" charset="0"/>
                    </a:rPr>
                    <a:t>b</a:t>
                  </a:r>
                  <a:r>
                    <a:rPr lang="de-DE" sz="7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  <a:r>
                    <a:rPr lang="de-DE" sz="75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tin</a:t>
                  </a:r>
                  <a:endParaRPr lang="en-US" sz="7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Textfeld 33"/>
                <p:cNvSpPr txBox="1"/>
                <p:nvPr/>
              </p:nvSpPr>
              <p:spPr>
                <a:xfrm>
                  <a:off x="4699983" y="1430604"/>
                  <a:ext cx="83456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7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AAT2</a:t>
                  </a:r>
                  <a:endParaRPr lang="en-US" sz="7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Textfeld 42"/>
                <p:cNvSpPr txBox="1"/>
                <p:nvPr/>
              </p:nvSpPr>
              <p:spPr>
                <a:xfrm>
                  <a:off x="2459764" y="2552751"/>
                  <a:ext cx="11761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75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ynaptotagmin</a:t>
                  </a:r>
                  <a:r>
                    <a:rPr lang="de-DE" sz="7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1</a:t>
                  </a:r>
                  <a:endParaRPr lang="en-US" sz="788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1" name="Textfeld 50"/>
                <p:cNvSpPr txBox="1"/>
                <p:nvPr/>
              </p:nvSpPr>
              <p:spPr>
                <a:xfrm>
                  <a:off x="6093764" y="2552751"/>
                  <a:ext cx="114164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7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EAAT2</a:t>
                  </a:r>
                  <a:endParaRPr lang="en-US" sz="788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" name="Rechteck 2"/>
                <p:cNvSpPr/>
                <p:nvPr/>
              </p:nvSpPr>
              <p:spPr>
                <a:xfrm>
                  <a:off x="509460" y="1177409"/>
                  <a:ext cx="432171" cy="2923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825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) </a:t>
                  </a:r>
                  <a:endParaRPr lang="en-US" sz="825" dirty="0"/>
                </a:p>
              </p:txBody>
            </p:sp>
            <p:sp>
              <p:nvSpPr>
                <p:cNvPr id="52" name="Rechteck 51"/>
                <p:cNvSpPr/>
                <p:nvPr/>
              </p:nvSpPr>
              <p:spPr>
                <a:xfrm>
                  <a:off x="4519485" y="1177409"/>
                  <a:ext cx="423621" cy="292388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825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B) </a:t>
                  </a:r>
                  <a:endParaRPr lang="en-US" sz="825" dirty="0"/>
                </a:p>
              </p:txBody>
            </p:sp>
            <p:pic>
              <p:nvPicPr>
                <p:cNvPr id="3074" name="Picture 2" descr="J:\Neuer Ordner\ERC\images\WB\EAAT2\Montage.tif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388170" y="1267249"/>
                  <a:ext cx="2712223" cy="81915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54" name="Gruppieren 53"/>
                <p:cNvGrpSpPr/>
                <p:nvPr/>
              </p:nvGrpSpPr>
              <p:grpSpPr>
                <a:xfrm>
                  <a:off x="5366029" y="2116907"/>
                  <a:ext cx="2993971" cy="377603"/>
                  <a:chOff x="6187238" y="1085522"/>
                  <a:chExt cx="2993971" cy="377600"/>
                </a:xfrm>
              </p:grpSpPr>
              <p:sp>
                <p:nvSpPr>
                  <p:cNvPr id="55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187238" y="1094790"/>
                    <a:ext cx="704554" cy="24621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ehicle</a:t>
                    </a:r>
                    <a:endParaRPr lang="en-GB" sz="6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6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05994" y="1103363"/>
                    <a:ext cx="704554" cy="24621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7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84771" y="1085522"/>
                    <a:ext cx="704554" cy="24621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 (I:C)</a:t>
                    </a:r>
                    <a:endParaRPr lang="en-GB" sz="6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8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129513" y="1093793"/>
                    <a:ext cx="1051696" cy="36932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</a:t>
                    </a:r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/</a:t>
                    </a:r>
                  </a:p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</p:grpSp>
            <p:pic>
              <p:nvPicPr>
                <p:cNvPr id="3075" name="Picture 3" descr="J:\Neuer Ordner\ERC\images\WB\Syt1 cropping\Montage.tif"/>
                <p:cNvPicPr preferRelativeResize="0">
                  <a:picLocks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55659" y="1266424"/>
                  <a:ext cx="2728800" cy="8208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59" name="Gruppieren 58"/>
                <p:cNvGrpSpPr/>
                <p:nvPr/>
              </p:nvGrpSpPr>
              <p:grpSpPr>
                <a:xfrm>
                  <a:off x="1612319" y="2132864"/>
                  <a:ext cx="2929317" cy="369333"/>
                  <a:chOff x="6251892" y="1093793"/>
                  <a:chExt cx="2929317" cy="369330"/>
                </a:xfrm>
              </p:grpSpPr>
              <p:sp>
                <p:nvSpPr>
                  <p:cNvPr id="60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251892" y="1094790"/>
                    <a:ext cx="704555" cy="24622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ehicle</a:t>
                    </a:r>
                    <a:endParaRPr lang="en-GB" sz="6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1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79885" y="1103364"/>
                    <a:ext cx="704555" cy="24622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2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658663" y="1094758"/>
                    <a:ext cx="704555" cy="24622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 (I:C)</a:t>
                    </a:r>
                    <a:endParaRPr lang="en-GB" sz="6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3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129513" y="1093793"/>
                    <a:ext cx="1051696" cy="36933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</a:t>
                    </a:r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/</a:t>
                    </a:r>
                  </a:p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64" name="Gruppieren 63"/>
                <p:cNvGrpSpPr/>
                <p:nvPr/>
              </p:nvGrpSpPr>
              <p:grpSpPr>
                <a:xfrm>
                  <a:off x="5657001" y="4830383"/>
                  <a:ext cx="2190852" cy="369332"/>
                  <a:chOff x="6624589" y="3008109"/>
                  <a:chExt cx="2084016" cy="369332"/>
                </a:xfrm>
                <a:noFill/>
              </p:grpSpPr>
              <p:sp>
                <p:nvSpPr>
                  <p:cNvPr id="65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120705" y="3025904"/>
                    <a:ext cx="509553" cy="246221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6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092135" y="3008109"/>
                    <a:ext cx="616470" cy="36933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/</a:t>
                    </a:r>
                  </a:p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7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43529" y="3029078"/>
                    <a:ext cx="632379" cy="246221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68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624589" y="3017821"/>
                    <a:ext cx="546255" cy="246221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ehicle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70" name="Gruppieren 69"/>
                <p:cNvGrpSpPr/>
                <p:nvPr/>
              </p:nvGrpSpPr>
              <p:grpSpPr>
                <a:xfrm>
                  <a:off x="2024586" y="4838652"/>
                  <a:ext cx="2259383" cy="369332"/>
                  <a:chOff x="6559400" y="3008109"/>
                  <a:chExt cx="2149205" cy="369332"/>
                </a:xfrm>
                <a:noFill/>
              </p:grpSpPr>
              <p:sp>
                <p:nvSpPr>
                  <p:cNvPr id="71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115469" y="3025904"/>
                    <a:ext cx="514788" cy="246221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2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8092135" y="3008109"/>
                    <a:ext cx="616470" cy="369332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IFN-</a:t>
                    </a:r>
                    <a:r>
                      <a:rPr lang="en-GB" sz="600" b="1" dirty="0">
                        <a:latin typeface="Symbol" panose="05050102010706020507" pitchFamily="18" charset="2"/>
                        <a:cs typeface="Times New Roman" panose="02020603050405020304" pitchFamily="18" charset="0"/>
                      </a:rPr>
                      <a:t>a/</a:t>
                    </a:r>
                  </a:p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3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551027" y="3029078"/>
                    <a:ext cx="624879" cy="246221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Poly(I:C)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4" name="9 CuadroTexto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559400" y="3020762"/>
                    <a:ext cx="556068" cy="246221"/>
                  </a:xfrm>
                  <a:prstGeom prst="rect">
                    <a:avLst/>
                  </a:prstGeom>
                  <a:grp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wrap="square">
                    <a:spAutoFit/>
                  </a:bodyPr>
                  <a:lstStyle/>
                  <a:p>
                    <a:pPr algn="ctr"/>
                    <a:r>
                      <a:rPr lang="en-GB" sz="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Vehicle</a:t>
                    </a:r>
                    <a:endParaRPr lang="en-GB" sz="600" i="1" dirty="0">
                      <a:latin typeface="Symbol" panose="05050102010706020507" pitchFamily="18" charset="2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</p:grpSp>
        <p:sp>
          <p:nvSpPr>
            <p:cNvPr id="38" name="Rechteck 37"/>
            <p:cNvSpPr/>
            <p:nvPr/>
          </p:nvSpPr>
          <p:spPr>
            <a:xfrm>
              <a:off x="2715894" y="26011"/>
              <a:ext cx="6428105" cy="67710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nchez-Mendoza, et al.</a:t>
              </a:r>
              <a:endParaRPr 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feron-α and TLR3 activation-induced depression associated with compromised hippocampal plasticity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443122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7</Words>
  <Application>Microsoft Office PowerPoint</Application>
  <PresentationFormat>On-screen Show (4:3)</PresentationFormat>
  <Paragraphs>3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Ess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anchez-mendoza, Eduardo</dc:creator>
  <cp:lastModifiedBy>MQUILIOPE</cp:lastModifiedBy>
  <cp:revision>475</cp:revision>
  <cp:lastPrinted>2019-03-06T11:43:59Z</cp:lastPrinted>
  <dcterms:created xsi:type="dcterms:W3CDTF">2018-09-05T14:08:24Z</dcterms:created>
  <dcterms:modified xsi:type="dcterms:W3CDTF">2020-05-22T07:21:09Z</dcterms:modified>
</cp:coreProperties>
</file>